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5" d="100"/>
          <a:sy n="95" d="100"/>
        </p:scale>
        <p:origin x="-1566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0" y="-33610"/>
            <a:ext cx="6858000" cy="10772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US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upplementary Table 2.</a:t>
            </a: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Quantification of band intensities for blot reported in Figure 3E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. Quantification was performed using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ImageJ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Arial" pitchFamily="34" charset="0"/>
              </a:rPr>
              <a:t>1.47q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oftware. After normalization to corresponding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vinculin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, normalized values for each treatment (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irolimus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at different doses) were compared to the corresponding band of the untreated (control) sample.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93688" y="1107082"/>
            <a:ext cx="6275387" cy="6345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54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zucovalentina</cp:lastModifiedBy>
  <cp:revision>13</cp:revision>
  <dcterms:created xsi:type="dcterms:W3CDTF">2024-08-02T07:16:01Z</dcterms:created>
  <dcterms:modified xsi:type="dcterms:W3CDTF">2024-08-02T07:39:30Z</dcterms:modified>
</cp:coreProperties>
</file>